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4A7213-24BB-4050-9539-C709F5F9E273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AA3BAE-9A5F-42E8-AA3E-A1584D7FA0B7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D98C03-E217-4466-9A57-5235FEAE1B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9F132-516C-4F9E-8806-88831CA8E5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7D38C0-B387-4110-949F-696D737901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72C4C-01CA-4EA8-9EB2-EFDC8A83BD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7E2DF1-BC28-47D3-975D-887A9FCACB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810DE-3B0A-4995-88F7-92125F3A3F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4860FD-54E5-442D-8D0F-6D5999455D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F4AA45-5639-447E-B3CB-F0B6831C54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E1F5E-A022-42B2-846A-5E629EDA98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1A95F-2515-4885-9E73-5736116224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BF350F-32C2-4C1D-9956-0B256702A7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7B1B1-7365-424F-8207-FAF70C46C9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ECE58E-E126-45A5-B340-ABAFA0196F3C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グラフ 6" descr=""/>
          <p:cNvPicPr/>
          <p:nvPr/>
        </p:nvPicPr>
        <p:blipFill>
          <a:blip r:embed="rId1"/>
          <a:stretch/>
        </p:blipFill>
        <p:spPr>
          <a:xfrm>
            <a:off x="1542960" y="1414440"/>
            <a:ext cx="6272280" cy="4102200"/>
          </a:xfrm>
          <a:prstGeom prst="rect">
            <a:avLst/>
          </a:prstGeom>
          <a:ln w="0">
            <a:noFill/>
          </a:ln>
        </p:spPr>
      </p:pic>
      <p:sp>
        <p:nvSpPr>
          <p:cNvPr id="49" name="テキスト ボックス 3"/>
          <p:cNvSpPr/>
          <p:nvPr/>
        </p:nvSpPr>
        <p:spPr>
          <a:xfrm>
            <a:off x="10800" y="260280"/>
            <a:ext cx="560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3. The DPPH radical scavenging activity of tomato-containing fish foo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直線コネクタ 3"/>
          <p:cNvSpPr/>
          <p:nvPr/>
        </p:nvSpPr>
        <p:spPr>
          <a:xfrm>
            <a:off x="3780000" y="1916280"/>
            <a:ext cx="2557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4"/>
          <p:cNvSpPr/>
          <p:nvPr/>
        </p:nvSpPr>
        <p:spPr>
          <a:xfrm>
            <a:off x="4977000" y="15462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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16"/>
          <p:cNvSpPr/>
          <p:nvPr/>
        </p:nvSpPr>
        <p:spPr>
          <a:xfrm>
            <a:off x="4713120" y="5950080"/>
            <a:ext cx="3396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&lt; 0.05, n =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ach error bar indicates the standard deviati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直線コネクタ 5"/>
          <p:cNvSpPr/>
          <p:nvPr/>
        </p:nvSpPr>
        <p:spPr>
          <a:xfrm>
            <a:off x="3780000" y="1916280"/>
            <a:ext cx="0" cy="1873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5T08:50:48Z</dcterms:created>
  <dc:creator>Y. Shimada</dc:creator>
  <dc:description/>
  <dc:language>en-US</dc:language>
  <cp:lastModifiedBy>Y. Shimada</cp:lastModifiedBy>
  <dcterms:modified xsi:type="dcterms:W3CDTF">2011-12-02T03:23:25Z</dcterms:modified>
  <cp:revision>8</cp:revision>
  <dc:subject/>
  <dc:title>Fig 1</dc:title>
</cp:coreProperties>
</file>